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45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0DE619-31E9-4EF4-B828-C87D8A604A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06F784-A680-4C23-8D7E-5877AF3729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7CD3CF-28C5-4AA8-8DA4-964A0E97E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EBD59A-A9BF-45E7-A748-0946F8315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7ECC26-13C7-439E-81A7-31CC9F73D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9204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6711E-47E9-4209-8C78-127AD6EC83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2A7910-BEB2-4769-8AF4-BEE0D326DA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E1EEC7-7BF9-4692-8B7E-CEB1AD1E65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4CEFB5-37B3-48D8-A1C6-771497139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E94110-8CBE-4BF3-B4C3-F0F565B31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32105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1B851AB-7ED7-41C2-91DB-9F6ACCB667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A4D89F-6C2D-42E4-B74C-C15457AF3F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8007C7-43F9-4996-8F56-C56283876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873937-A493-4265-836D-607686B92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012583-76DC-4859-AD5B-C731671B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327469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4780E1-A6CC-4CEB-A403-099525CA7D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FA3DB6-88A1-4F9A-B2DF-100186EFC9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86DEAB-2BF0-4C35-B768-FDDEAC986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FC5955-13C8-4B77-9704-2343C2565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05D1AE-3E8C-454D-BABB-3884B1794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76473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0B5AA5-8B02-4FE0-8379-02E19C6F8B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3D50BA-6AAC-4179-804D-DD584D98F5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0C33AA-D607-4A2D-8361-C1262240C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7A5FAF-9AAE-405F-A7CC-CE4F102B4E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04C247-5DF5-4082-A3D8-53B0DFC0D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62690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8E3FFB-46BE-4F02-8D61-5D306D67C0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A2BFB7-5B02-45FE-BC31-FE42288960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F10FAE-8EF7-482B-90B3-B1960DFFE2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B019A5-B0EF-4BEB-B17A-E8FA08CD0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023E9B-ECF0-49CD-ADC8-B49B4E4AF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62FF78-97F9-4D03-AE11-5E622FFA5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53413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E1BB5C-E634-45FD-B453-74B07726A2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46155C-84F6-4612-8169-2C56C85905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648C4C-88B5-4E4E-9131-4E798B0729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8BADAB-F9E3-419F-9DAB-3D970178D1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FB4AF7-F219-41BC-ADF5-778D9A74EB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27AED8-7954-4856-8CE4-1F7D47DFB0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6F08A3-C6E2-4492-B22A-C7745DB71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8FBC22-473C-4FD4-96D7-755C27BF2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15991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F519D8-3AA5-45A8-B8AF-D72C55ED8B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074B47-14E7-4161-BACA-ADA45D83A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28E4B1-0A2B-455C-8D3E-6D2E3CE76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D8EC6A-72EE-457E-B78B-215F5B486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65069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CAE16F1-9784-487B-B4B3-5749C8932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E7E8B8-0F8C-4F0E-B084-731AF41C3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1E2D77-C7C1-45D9-BCB6-4E590D872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48730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D71807-9E67-4665-A7C3-9A3FFC91B2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F50306-EB2E-408E-B969-9685EC5D6E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4FC2C8-F7FC-4FAE-955C-8A45053FAB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7E5DCD-4004-4C8D-8FB5-4C1ED93D5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936558-B379-401D-B95F-23892C342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0B3846-18D6-44D4-93D7-771E5A708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095421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589BC4-AACC-44BD-A839-393C9B9F05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63AFD93-0E62-47BF-97DF-050090F459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938EA0-22F9-4E57-914B-C56825B357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E8B98-EB36-4D32-A55E-52CC9763D1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6C8F5D-D7A7-427E-A07B-8A649F5B3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134A19-725A-45A2-B838-B1C76EF01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5035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11B0C5-E093-45FF-ACE6-C9620D507D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2C1EF9-9BF9-43CE-9F94-0007FE1FAA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D50E53-9689-4465-92E5-01424CDB60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83A80-4563-43E4-ABD8-E1E345238795}" type="datetimeFigureOut">
              <a:rPr lang="en-AU" smtClean="0"/>
              <a:t>5/07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F31DE3-381B-4100-B0FC-D9CBECB072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EA5CDE-8130-4889-B556-F7183E4D94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E4856-C365-4037-A910-195E7C6905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7466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A9900B05-2E82-447F-996B-94E325CEF158}"/>
              </a:ext>
            </a:extLst>
          </p:cNvPr>
          <p:cNvGrpSpPr/>
          <p:nvPr/>
        </p:nvGrpSpPr>
        <p:grpSpPr>
          <a:xfrm>
            <a:off x="696413" y="113767"/>
            <a:ext cx="10026746" cy="2096221"/>
            <a:chOff x="1203715" y="1106891"/>
            <a:chExt cx="10221224" cy="224590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A9E8F54-3668-4514-A982-28868A6255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7596"/>
            <a:stretch/>
          </p:blipFill>
          <p:spPr>
            <a:xfrm>
              <a:off x="1359637" y="1160147"/>
              <a:ext cx="10065302" cy="2192651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F87BCC0-0B23-4A03-9AA1-97FA381E6379}"/>
                </a:ext>
              </a:extLst>
            </p:cNvPr>
            <p:cNvSpPr txBox="1"/>
            <p:nvPr/>
          </p:nvSpPr>
          <p:spPr>
            <a:xfrm>
              <a:off x="1203715" y="1106891"/>
              <a:ext cx="317716" cy="395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F37D48F-4EC4-450F-A344-656488BFCED8}"/>
              </a:ext>
            </a:extLst>
          </p:cNvPr>
          <p:cNvGrpSpPr/>
          <p:nvPr/>
        </p:nvGrpSpPr>
        <p:grpSpPr>
          <a:xfrm>
            <a:off x="772613" y="2088130"/>
            <a:ext cx="9865563" cy="2310111"/>
            <a:chOff x="1314132" y="3662613"/>
            <a:chExt cx="10123507" cy="2310111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00C61ED-9A66-4E39-B741-83AB663133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7438"/>
            <a:stretch/>
          </p:blipFill>
          <p:spPr>
            <a:xfrm>
              <a:off x="1335332" y="3776329"/>
              <a:ext cx="10102307" cy="2196395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EDDC5CB-89B2-44F0-A9BC-B0656AB6A047}"/>
                </a:ext>
              </a:extLst>
            </p:cNvPr>
            <p:cNvSpPr txBox="1"/>
            <p:nvPr/>
          </p:nvSpPr>
          <p:spPr>
            <a:xfrm>
              <a:off x="1314132" y="3662613"/>
              <a:ext cx="3227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</a:t>
              </a:r>
            </a:p>
          </p:txBody>
        </p:sp>
      </p:grp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45513BC3-7149-4EE7-827E-95ED9EA3888E}"/>
              </a:ext>
            </a:extLst>
          </p:cNvPr>
          <p:cNvCxnSpPr>
            <a:cxnSpLocks/>
          </p:cNvCxnSpPr>
          <p:nvPr/>
        </p:nvCxnSpPr>
        <p:spPr>
          <a:xfrm flipV="1">
            <a:off x="2203265" y="1588926"/>
            <a:ext cx="0" cy="2293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4CBDB63-1F4D-4965-87C1-73002DBCD873}"/>
              </a:ext>
            </a:extLst>
          </p:cNvPr>
          <p:cNvCxnSpPr>
            <a:cxnSpLocks/>
          </p:cNvCxnSpPr>
          <p:nvPr/>
        </p:nvCxnSpPr>
        <p:spPr>
          <a:xfrm flipV="1">
            <a:off x="2124797" y="3888987"/>
            <a:ext cx="0" cy="2293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DC1F44CF-ACDD-4CAC-A398-B18E2F899FC9}"/>
              </a:ext>
            </a:extLst>
          </p:cNvPr>
          <p:cNvSpPr txBox="1"/>
          <p:nvPr/>
        </p:nvSpPr>
        <p:spPr>
          <a:xfrm>
            <a:off x="11027253" y="60308"/>
            <a:ext cx="883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. </a:t>
            </a:r>
            <a:r>
              <a:rPr lang="en-AU"/>
              <a:t>3</a:t>
            </a:r>
            <a:endParaRPr lang="en-AU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0A9A9BD-6886-4FD6-ABCE-352525E40153}"/>
              </a:ext>
            </a:extLst>
          </p:cNvPr>
          <p:cNvSpPr txBox="1"/>
          <p:nvPr/>
        </p:nvSpPr>
        <p:spPr>
          <a:xfrm>
            <a:off x="57335" y="4878644"/>
            <a:ext cx="1207732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Supplementary 3</a:t>
            </a:r>
            <a:r>
              <a:rPr lang="en-AU" sz="1400" dirty="0"/>
              <a:t>: 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between sperm quality and  (a) maximum Temperature  (</a:t>
            </a:r>
            <a:r>
              <a:rPr lang="en-AU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ax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 (b) Temperature Humidity Index  (THI).  The Y axis is the Pearson correlation coefficient and X axis is the lag, i.e. the number of days before the day the sperm sample was taken, at which </a:t>
            </a:r>
            <a:r>
              <a:rPr lang="en-AU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ax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THI was taken to correlate with sperm quality. The panels represent the number of days that were averaged to form </a:t>
            </a:r>
            <a:r>
              <a:rPr lang="en-AU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ax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THI. The first panel at left is for correlations with </a:t>
            </a:r>
            <a:r>
              <a:rPr lang="en-AU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ax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THI for a single day. The remaining 4 panels contain the correlations between sperm quality and the average of 2, 3, 4 and 5 days of </a:t>
            </a:r>
            <a:r>
              <a:rPr lang="en-AU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ax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THI. The smoother appearance of the correlation pattern in these panels is a result of the averaging of </a:t>
            </a:r>
            <a:r>
              <a:rPr lang="en-AU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ax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THI values over multiple days. The overriding pattern is the correlation between sperm quality and </a:t>
            </a:r>
            <a:r>
              <a:rPr lang="en-AU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ax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THI peaks at about 17-19 days prior to the sperm sample being taken and is substantially greater, ranging from about r=-.42 to -.45, than it is on the same day  (lag 0), about r=-0.29, or for longer periods. </a:t>
            </a:r>
            <a:endParaRPr lang="en-AU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AU" sz="1400" dirty="0"/>
          </a:p>
        </p:txBody>
      </p:sp>
    </p:spTree>
    <p:extLst>
      <p:ext uri="{BB962C8B-B14F-4D97-AF65-F5344CB8AC3E}">
        <p14:creationId xmlns:p14="http://schemas.microsoft.com/office/powerpoint/2010/main" val="34195646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1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Baker</dc:creator>
  <cp:lastModifiedBy>Mark Baker</cp:lastModifiedBy>
  <cp:revision>4</cp:revision>
  <dcterms:created xsi:type="dcterms:W3CDTF">2022-06-20T23:46:38Z</dcterms:created>
  <dcterms:modified xsi:type="dcterms:W3CDTF">2022-07-05T01:50:39Z</dcterms:modified>
</cp:coreProperties>
</file>